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1 (2)'!$C$1</c:f>
              <c:strCache>
                <c:ptCount val="1"/>
                <c:pt idx="0">
                  <c:v>Positiv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multiLvlStrRef>
              <c:f>'sheet1 (2)'!$A$2:$B$21</c:f>
              <c:multiLvlStrCache>
                <c:ptCount val="20"/>
                <c:lvl>
                  <c:pt idx="0">
                    <c:v>w2 </c:v>
                  </c:pt>
                  <c:pt idx="1">
                    <c:v>w3 </c:v>
                  </c:pt>
                  <c:pt idx="2">
                    <c:v>w4 </c:v>
                  </c:pt>
                  <c:pt idx="3">
                    <c:v>w3 </c:v>
                  </c:pt>
                  <c:pt idx="4">
                    <c:v>w3 </c:v>
                  </c:pt>
                  <c:pt idx="5">
                    <c:v>w4</c:v>
                  </c:pt>
                  <c:pt idx="6">
                    <c:v>w1 </c:v>
                  </c:pt>
                  <c:pt idx="7">
                    <c:v>w2 </c:v>
                  </c:pt>
                  <c:pt idx="8">
                    <c:v>w3 </c:v>
                  </c:pt>
                  <c:pt idx="9">
                    <c:v>w4 </c:v>
                  </c:pt>
                  <c:pt idx="10">
                    <c:v>w1 </c:v>
                  </c:pt>
                  <c:pt idx="11">
                    <c:v>w2 </c:v>
                  </c:pt>
                  <c:pt idx="12">
                    <c:v>w2 </c:v>
                  </c:pt>
                  <c:pt idx="13">
                    <c:v>w4 </c:v>
                  </c:pt>
                  <c:pt idx="14">
                    <c:v>w1 </c:v>
                  </c:pt>
                  <c:pt idx="15">
                    <c:v>w3 </c:v>
                  </c:pt>
                  <c:pt idx="16">
                    <c:v>w4 </c:v>
                  </c:pt>
                  <c:pt idx="17">
                    <c:v>w1 </c:v>
                  </c:pt>
                  <c:pt idx="18">
                    <c:v>w3 </c:v>
                  </c:pt>
                  <c:pt idx="19">
                    <c:v>w3 </c:v>
                  </c:pt>
                </c:lvl>
                <c:lvl>
                  <c:pt idx="0">
                    <c:v>Sep-20</c:v>
                  </c:pt>
                  <c:pt idx="3">
                    <c:v>Oct-20</c:v>
                  </c:pt>
                  <c:pt idx="4">
                    <c:v>Nov-20</c:v>
                  </c:pt>
                  <c:pt idx="6">
                    <c:v>Dec-20</c:v>
                  </c:pt>
                  <c:pt idx="10">
                    <c:v>Jan-21</c:v>
                  </c:pt>
                  <c:pt idx="12">
                    <c:v>Feb-21</c:v>
                  </c:pt>
                  <c:pt idx="14">
                    <c:v>Mar-21</c:v>
                  </c:pt>
                  <c:pt idx="17">
                    <c:v>Apr-21</c:v>
                  </c:pt>
                  <c:pt idx="19">
                    <c:v>May-21</c:v>
                  </c:pt>
                </c:lvl>
              </c:multiLvlStrCache>
            </c:multiLvlStrRef>
          </c:cat>
          <c:val>
            <c:numRef>
              <c:f>'sheet1 (2)'!$C$2:$C$21</c:f>
              <c:numCache>
                <c:formatCode>General</c:formatCode>
                <c:ptCount val="20"/>
                <c:pt idx="0">
                  <c:v>6</c:v>
                </c:pt>
                <c:pt idx="1">
                  <c:v>11</c:v>
                </c:pt>
                <c:pt idx="2">
                  <c:v>44</c:v>
                </c:pt>
                <c:pt idx="3">
                  <c:v>24</c:v>
                </c:pt>
                <c:pt idx="4">
                  <c:v>10</c:v>
                </c:pt>
                <c:pt idx="5">
                  <c:v>13</c:v>
                </c:pt>
                <c:pt idx="6">
                  <c:v>9</c:v>
                </c:pt>
                <c:pt idx="7">
                  <c:v>19</c:v>
                </c:pt>
                <c:pt idx="8">
                  <c:v>17</c:v>
                </c:pt>
                <c:pt idx="9">
                  <c:v>14</c:v>
                </c:pt>
                <c:pt idx="10">
                  <c:v>12</c:v>
                </c:pt>
                <c:pt idx="11">
                  <c:v>3</c:v>
                </c:pt>
                <c:pt idx="12">
                  <c:v>2</c:v>
                </c:pt>
                <c:pt idx="13">
                  <c:v>1</c:v>
                </c:pt>
                <c:pt idx="14">
                  <c:v>2</c:v>
                </c:pt>
                <c:pt idx="15">
                  <c:v>4</c:v>
                </c:pt>
                <c:pt idx="16">
                  <c:v>24</c:v>
                </c:pt>
                <c:pt idx="17">
                  <c:v>8</c:v>
                </c:pt>
                <c:pt idx="18">
                  <c:v>1</c:v>
                </c:pt>
                <c:pt idx="1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61-4258-AABB-B977BA4DBFEC}"/>
            </c:ext>
          </c:extLst>
        </c:ser>
        <c:ser>
          <c:idx val="1"/>
          <c:order val="1"/>
          <c:tx>
            <c:strRef>
              <c:f>'sheet1 (2)'!$D$1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sheet1 (2)'!$A$2:$B$21</c:f>
              <c:multiLvlStrCache>
                <c:ptCount val="20"/>
                <c:lvl>
                  <c:pt idx="0">
                    <c:v>w2 </c:v>
                  </c:pt>
                  <c:pt idx="1">
                    <c:v>w3 </c:v>
                  </c:pt>
                  <c:pt idx="2">
                    <c:v>w4 </c:v>
                  </c:pt>
                  <c:pt idx="3">
                    <c:v>w3 </c:v>
                  </c:pt>
                  <c:pt idx="4">
                    <c:v>w3 </c:v>
                  </c:pt>
                  <c:pt idx="5">
                    <c:v>w4</c:v>
                  </c:pt>
                  <c:pt idx="6">
                    <c:v>w1 </c:v>
                  </c:pt>
                  <c:pt idx="7">
                    <c:v>w2 </c:v>
                  </c:pt>
                  <c:pt idx="8">
                    <c:v>w3 </c:v>
                  </c:pt>
                  <c:pt idx="9">
                    <c:v>w4 </c:v>
                  </c:pt>
                  <c:pt idx="10">
                    <c:v>w1 </c:v>
                  </c:pt>
                  <c:pt idx="11">
                    <c:v>w2 </c:v>
                  </c:pt>
                  <c:pt idx="12">
                    <c:v>w2 </c:v>
                  </c:pt>
                  <c:pt idx="13">
                    <c:v>w4 </c:v>
                  </c:pt>
                  <c:pt idx="14">
                    <c:v>w1 </c:v>
                  </c:pt>
                  <c:pt idx="15">
                    <c:v>w3 </c:v>
                  </c:pt>
                  <c:pt idx="16">
                    <c:v>w4 </c:v>
                  </c:pt>
                  <c:pt idx="17">
                    <c:v>w1 </c:v>
                  </c:pt>
                  <c:pt idx="18">
                    <c:v>w3 </c:v>
                  </c:pt>
                  <c:pt idx="19">
                    <c:v>w3 </c:v>
                  </c:pt>
                </c:lvl>
                <c:lvl>
                  <c:pt idx="0">
                    <c:v>Sep-20</c:v>
                  </c:pt>
                  <c:pt idx="3">
                    <c:v>Oct-20</c:v>
                  </c:pt>
                  <c:pt idx="4">
                    <c:v>Nov-20</c:v>
                  </c:pt>
                  <c:pt idx="6">
                    <c:v>Dec-20</c:v>
                  </c:pt>
                  <c:pt idx="10">
                    <c:v>Jan-21</c:v>
                  </c:pt>
                  <c:pt idx="12">
                    <c:v>Feb-21</c:v>
                  </c:pt>
                  <c:pt idx="14">
                    <c:v>Mar-21</c:v>
                  </c:pt>
                  <c:pt idx="17">
                    <c:v>Apr-21</c:v>
                  </c:pt>
                  <c:pt idx="19">
                    <c:v>May-21</c:v>
                  </c:pt>
                </c:lvl>
              </c:multiLvlStrCache>
            </c:multiLvlStrRef>
          </c:cat>
          <c:val>
            <c:numRef>
              <c:f>'sheet1 (2)'!$D$2:$D$21</c:f>
              <c:numCache>
                <c:formatCode>General</c:formatCode>
                <c:ptCount val="20"/>
                <c:pt idx="0">
                  <c:v>16</c:v>
                </c:pt>
                <c:pt idx="1">
                  <c:v>49</c:v>
                </c:pt>
                <c:pt idx="2">
                  <c:v>98</c:v>
                </c:pt>
                <c:pt idx="3">
                  <c:v>35</c:v>
                </c:pt>
                <c:pt idx="4">
                  <c:v>13</c:v>
                </c:pt>
                <c:pt idx="5">
                  <c:v>17</c:v>
                </c:pt>
                <c:pt idx="6">
                  <c:v>14</c:v>
                </c:pt>
                <c:pt idx="7">
                  <c:v>31</c:v>
                </c:pt>
                <c:pt idx="8">
                  <c:v>32</c:v>
                </c:pt>
                <c:pt idx="9">
                  <c:v>33</c:v>
                </c:pt>
                <c:pt idx="10">
                  <c:v>33</c:v>
                </c:pt>
                <c:pt idx="11">
                  <c:v>9</c:v>
                </c:pt>
                <c:pt idx="12">
                  <c:v>3</c:v>
                </c:pt>
                <c:pt idx="13">
                  <c:v>4</c:v>
                </c:pt>
                <c:pt idx="14">
                  <c:v>7</c:v>
                </c:pt>
                <c:pt idx="15">
                  <c:v>8</c:v>
                </c:pt>
                <c:pt idx="16">
                  <c:v>39</c:v>
                </c:pt>
                <c:pt idx="17">
                  <c:v>9</c:v>
                </c:pt>
                <c:pt idx="18">
                  <c:v>14</c:v>
                </c:pt>
                <c:pt idx="19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61-4258-AABB-B977BA4DBF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6265391"/>
        <c:axId val="527216303"/>
      </c:barChart>
      <c:catAx>
        <c:axId val="6262653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7216303"/>
        <c:crosses val="autoZero"/>
        <c:auto val="1"/>
        <c:lblAlgn val="ctr"/>
        <c:lblOffset val="100"/>
        <c:noMultiLvlLbl val="0"/>
      </c:catAx>
      <c:valAx>
        <c:axId val="52721630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=504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62653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5489723162664027"/>
          <c:y val="0.18506449680802889"/>
          <c:w val="0.2956115116863377"/>
          <c:h val="0.114101062042569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786CFB-D9B7-438E-A404-8E65D3737B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A41CD9-0425-496D-9364-E9A62B390D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84CA9F-57DE-49B6-A84D-D5AD302FB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38F18C-756D-4978-8748-6462BE020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C8D736-A39C-4059-8872-320865D55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935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57CF3-73B4-401D-A7C5-635C78C25E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00C86B-123D-41C7-8DE4-F611A19037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F53DB1-5E27-4394-A33C-68E636563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70260A-630C-4DDD-B820-72096475B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30CAC7-3EA4-4475-AF69-0CF55E040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741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E78515-67B5-4AFA-808A-362E1E21E0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FA5634-4610-42FA-98F0-EEDA59428D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F2CAFE-8D5C-4D34-B616-2CDCF66F5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2CEBB4-6BE2-4E31-B55D-38B0804C8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29DFA8-799E-42DA-9CFF-B4C237C88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883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5CDC1-E56C-45B5-B33B-1DB2B56D61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D79B39-B068-49F5-98D7-71E022A06E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074FAB-8CCD-4517-B92E-BA16E70B8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217BA3-FAD7-49BF-A5A6-2C44DE286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0AF7E2-658C-43A5-8BD7-CBDD1F15F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7923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0AE1D9-90C4-4C7B-9985-C45F5A648A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9ED086-50C6-4A73-8388-36FB7F8FB0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FCB1C7-5EE1-4337-BDBD-1F32FDBA7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4C77ED-9F5C-4FA6-B7E7-A1ED36D37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8B05F-8794-43D4-9E89-9F3F55B10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6496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9E79D-0CC5-4A1C-990D-F5E04F4B5A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C22D8D-7B89-47DF-A438-64D6209336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A51DBC-EEB6-4FEE-8656-9EA5F97857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A9BFEC-CFE9-4986-953B-B2F85B42A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3C8F47-BD8A-439E-8A86-107940C8F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760954-36ED-40FA-91BE-4BA67FF2F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002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49364D-9E02-4E91-8956-4127549668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572C4A-93C2-45C9-B648-0621E52DD1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2B5916-3A93-44B9-8C57-DC476249A5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5DA0123-31D5-4CC5-901E-B4D34F2B82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BD0E1F-4E76-41B1-A694-089CCEB71C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D46BCB-6F5F-4F71-8E44-EC01E49595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F3BA7F-D5E1-4E2E-A86F-DEC5DDD5A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8A830B-AF57-4A49-B185-2FE72F232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3420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69ADE-0152-4722-9546-D09A822F98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789C3D-9949-4956-937E-C3DC1FBA1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F31E97-C2E1-4917-A2AB-1DF6B0105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C05AD2-5C6E-4E03-BE9D-2C77AA881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2524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4CCC52-7A94-4169-AA31-B10F3CA16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A2AC234-AE83-4E87-BFED-5FE5DAD12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CFB51A-7EF8-432D-ABB4-2377069E2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1700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42E5FF-8B1A-437E-9BB5-002010B432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958019-C5F5-4409-8270-A2B4962D88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89CE4F-8B02-426C-982B-D1708741AE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1985D3-0D94-40C4-A370-92F54F8AF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9B6BC8-96F4-4F17-B12B-8AB458FC4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FCDF45-74FA-4072-957A-B34E05622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2856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EACF3E-A57E-43C7-800B-C14E04A4A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CBF6FA-7220-4A6D-BBA2-1CC2AB979C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DBCCB0-BD67-4013-95BD-451FC10A15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E613BE-BAD6-40D0-9878-DB57311E3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F7E331-E70F-4BC5-A2A5-398EB15E2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1C8E55-7C08-46B6-9F33-359AAC411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3650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D509AC-B0CF-413B-976C-C8503EC23C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88ED40-38CF-4601-9F42-8862B721F5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55770C-5400-41CF-B2F4-5E554D883A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5988DE-B34A-44FA-B530-2225BB8C2F2F}" type="datetimeFigureOut">
              <a:rPr lang="en-GB" smtClean="0"/>
              <a:t>11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4C91A9-CD71-47D1-81A0-C9C811FA8D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2F5A4E-F3DA-418E-AFA3-07AA0ECBDB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62585-FC19-416F-BC97-2EA7DDF7DC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0085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2B685E0-8B91-42A8-B9C8-20CD0EE671FC}"/>
              </a:ext>
            </a:extLst>
          </p:cNvPr>
          <p:cNvGraphicFramePr/>
          <p:nvPr>
            <p:extLst/>
          </p:nvPr>
        </p:nvGraphicFramePr>
        <p:xfrm>
          <a:off x="2701255" y="1493241"/>
          <a:ext cx="7290033" cy="43790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67CEFCE3-F095-4061-A103-3D9EEDE8D09D}"/>
              </a:ext>
            </a:extLst>
          </p:cNvPr>
          <p:cNvSpPr/>
          <p:nvPr/>
        </p:nvSpPr>
        <p:spPr>
          <a:xfrm>
            <a:off x="3394745" y="5777647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weekly collection of wastewater samples from the same locations, covering the time frame from September 2020 to May 2021. 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35797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D745926-C5E3-4B02-8B0A-81105089B7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2708" y="468700"/>
            <a:ext cx="5285064" cy="479919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C26C1EC-59F7-442F-A25D-1CFA0B44E05C}"/>
              </a:ext>
            </a:extLst>
          </p:cNvPr>
          <p:cNvSpPr/>
          <p:nvPr/>
        </p:nvSpPr>
        <p:spPr>
          <a:xfrm>
            <a:off x="3422708" y="5267895"/>
            <a:ext cx="69404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0" i="0" dirty="0">
                <a:solidFill>
                  <a:srgbClr val="37415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2: A comparison of the viral load in the sewer network with the number of national COVID-19 cases. 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9166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Rehnuma Haque Sarah</dc:creator>
  <cp:lastModifiedBy>Dr. Rehnuma Haque Sarah</cp:lastModifiedBy>
  <cp:revision>1</cp:revision>
  <dcterms:created xsi:type="dcterms:W3CDTF">2023-06-11T05:21:52Z</dcterms:created>
  <dcterms:modified xsi:type="dcterms:W3CDTF">2023-06-11T05:22:31Z</dcterms:modified>
</cp:coreProperties>
</file>